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>
        <p:scale>
          <a:sx n="100" d="100"/>
          <a:sy n="100" d="100"/>
        </p:scale>
        <p:origin x="2678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2018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8714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2039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998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396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05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29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728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6629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8411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330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96F79-F065-4704-95B2-980FC08E9B66}" type="datetimeFigureOut">
              <a:rPr lang="zh-CN" altLang="en-US" smtClean="0"/>
              <a:t>2025/5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EFA7C-054C-4F8C-BB56-93EC17D1AA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6726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图片 51">
            <a:extLst>
              <a:ext uri="{FF2B5EF4-FFF2-40B4-BE49-F238E27FC236}">
                <a16:creationId xmlns:a16="http://schemas.microsoft.com/office/drawing/2014/main" id="{CD8A4988-C2B0-47BA-A344-9F7D82BD6B6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16560" y="503293"/>
            <a:ext cx="1475619" cy="152862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F8BF625-BE13-423C-9017-480C39522F9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52910" y="2200095"/>
            <a:ext cx="1557792" cy="94103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7C6C89B-C0DF-4CF8-8F47-58CF9627AE6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4413" y="756817"/>
            <a:ext cx="1531174" cy="94103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4133596-3572-44D1-911C-310311A69B8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1640" y="2200095"/>
            <a:ext cx="2823105" cy="941035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B5506DE2-3226-4B17-8F3D-F0E254B40253}"/>
              </a:ext>
            </a:extLst>
          </p:cNvPr>
          <p:cNvSpPr/>
          <p:nvPr/>
        </p:nvSpPr>
        <p:spPr>
          <a:xfrm>
            <a:off x="698424" y="1318982"/>
            <a:ext cx="994299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C5170560-B71A-4E80-913E-98637B41D7B4}"/>
              </a:ext>
            </a:extLst>
          </p:cNvPr>
          <p:cNvSpPr/>
          <p:nvPr/>
        </p:nvSpPr>
        <p:spPr>
          <a:xfrm>
            <a:off x="570077" y="2670611"/>
            <a:ext cx="994299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2574F6C-89B4-4E8B-BB75-B1F5B30E34EE}"/>
              </a:ext>
            </a:extLst>
          </p:cNvPr>
          <p:cNvSpPr/>
          <p:nvPr/>
        </p:nvSpPr>
        <p:spPr>
          <a:xfrm>
            <a:off x="4279480" y="805009"/>
            <a:ext cx="793978" cy="276999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249A78D3-FE82-4438-A90A-5E75057748E2}"/>
              </a:ext>
            </a:extLst>
          </p:cNvPr>
          <p:cNvSpPr/>
          <p:nvPr/>
        </p:nvSpPr>
        <p:spPr>
          <a:xfrm>
            <a:off x="4071655" y="2799338"/>
            <a:ext cx="826475" cy="255887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F18CB33-1A59-4E7E-ABB6-F75085BA6643}"/>
              </a:ext>
            </a:extLst>
          </p:cNvPr>
          <p:cNvSpPr txBox="1"/>
          <p:nvPr/>
        </p:nvSpPr>
        <p:spPr>
          <a:xfrm>
            <a:off x="-62381" y="280730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E141D3B-8476-40E6-87F5-833DD949A64B}"/>
              </a:ext>
            </a:extLst>
          </p:cNvPr>
          <p:cNvSpPr txBox="1"/>
          <p:nvPr/>
        </p:nvSpPr>
        <p:spPr>
          <a:xfrm>
            <a:off x="119013" y="13213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0311227-8B06-4D6F-9C06-A4DC81A98E77}"/>
              </a:ext>
            </a:extLst>
          </p:cNvPr>
          <p:cNvSpPr txBox="1"/>
          <p:nvPr/>
        </p:nvSpPr>
        <p:spPr>
          <a:xfrm>
            <a:off x="3519675" y="8854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7108E82-1A5C-481C-96C0-BAE1BD6378FF}"/>
              </a:ext>
            </a:extLst>
          </p:cNvPr>
          <p:cNvSpPr txBox="1"/>
          <p:nvPr/>
        </p:nvSpPr>
        <p:spPr>
          <a:xfrm>
            <a:off x="3387896" y="296456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618B16A-120E-4A36-950E-F475D63E00BE}"/>
              </a:ext>
            </a:extLst>
          </p:cNvPr>
          <p:cNvSpPr txBox="1"/>
          <p:nvPr/>
        </p:nvSpPr>
        <p:spPr>
          <a:xfrm>
            <a:off x="0" y="59060"/>
            <a:ext cx="10839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0F3577B-A007-4724-A6C6-E7B1A6F7B1F2}"/>
              </a:ext>
            </a:extLst>
          </p:cNvPr>
          <p:cNvSpPr txBox="1"/>
          <p:nvPr/>
        </p:nvSpPr>
        <p:spPr>
          <a:xfrm>
            <a:off x="4262741" y="25445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6B90E06-4BA0-4628-BE39-E99AAC3959D1}"/>
              </a:ext>
            </a:extLst>
          </p:cNvPr>
          <p:cNvSpPr txBox="1"/>
          <p:nvPr/>
        </p:nvSpPr>
        <p:spPr>
          <a:xfrm>
            <a:off x="1957071" y="1299435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6AA02F2-E813-4E81-9ACA-CBDBD7A97D91}"/>
              </a:ext>
            </a:extLst>
          </p:cNvPr>
          <p:cNvSpPr txBox="1"/>
          <p:nvPr/>
        </p:nvSpPr>
        <p:spPr>
          <a:xfrm>
            <a:off x="5427383" y="811221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9CD98C5-1AC2-440B-A1E4-D55CC4CC75E7}"/>
              </a:ext>
            </a:extLst>
          </p:cNvPr>
          <p:cNvSpPr txBox="1"/>
          <p:nvPr/>
        </p:nvSpPr>
        <p:spPr>
          <a:xfrm>
            <a:off x="5270791" y="2771373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62D811D-BD4E-438B-A701-7CF7840CC937}"/>
              </a:ext>
            </a:extLst>
          </p:cNvPr>
          <p:cNvSpPr txBox="1"/>
          <p:nvPr/>
        </p:nvSpPr>
        <p:spPr>
          <a:xfrm>
            <a:off x="684604" y="3213667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5C5C763-090A-4D5B-981B-1E37C485F255}"/>
              </a:ext>
            </a:extLst>
          </p:cNvPr>
          <p:cNvSpPr txBox="1"/>
          <p:nvPr/>
        </p:nvSpPr>
        <p:spPr>
          <a:xfrm>
            <a:off x="744184" y="464984"/>
            <a:ext cx="9211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AW264.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63DC036-8EF8-4FD2-AEC2-F9E3B0E24B82}"/>
              </a:ext>
            </a:extLst>
          </p:cNvPr>
          <p:cNvSpPr txBox="1"/>
          <p:nvPr/>
        </p:nvSpPr>
        <p:spPr>
          <a:xfrm>
            <a:off x="28101" y="5014476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FCE29EBB-DEBE-49A0-9ED4-1B72CDC719E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7646" y="5918048"/>
            <a:ext cx="1313895" cy="95879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5DFEB121-37FB-40A2-85D2-17A726FC394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93247" y="7033514"/>
            <a:ext cx="1216241" cy="958792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8041CA6D-DA89-403D-A892-45C39C946940}"/>
              </a:ext>
            </a:extLst>
          </p:cNvPr>
          <p:cNvSpPr txBox="1"/>
          <p:nvPr/>
        </p:nvSpPr>
        <p:spPr>
          <a:xfrm>
            <a:off x="1174040" y="620662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7546947-DF79-4F71-93E5-744ED6C1B7B1}"/>
              </a:ext>
            </a:extLst>
          </p:cNvPr>
          <p:cNvSpPr txBox="1"/>
          <p:nvPr/>
        </p:nvSpPr>
        <p:spPr>
          <a:xfrm>
            <a:off x="1114267" y="737441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A5A30649-0335-49BA-AE24-404387613F82}"/>
              </a:ext>
            </a:extLst>
          </p:cNvPr>
          <p:cNvSpPr/>
          <p:nvPr/>
        </p:nvSpPr>
        <p:spPr>
          <a:xfrm>
            <a:off x="1703399" y="6331628"/>
            <a:ext cx="795935" cy="188308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4CFA3592-68B9-4370-943F-07C57EF9FE74}"/>
              </a:ext>
            </a:extLst>
          </p:cNvPr>
          <p:cNvSpPr/>
          <p:nvPr/>
        </p:nvSpPr>
        <p:spPr>
          <a:xfrm>
            <a:off x="1635668" y="7295496"/>
            <a:ext cx="795935" cy="188308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6C9235D-89A8-4669-940A-6CBC7C4AC32E}"/>
              </a:ext>
            </a:extLst>
          </p:cNvPr>
          <p:cNvSpPr txBox="1"/>
          <p:nvPr/>
        </p:nvSpPr>
        <p:spPr>
          <a:xfrm>
            <a:off x="1774588" y="5592154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F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467EDC8-C1B7-4C62-9B55-30C96F0FE52D}"/>
              </a:ext>
            </a:extLst>
          </p:cNvPr>
          <p:cNvSpPr txBox="1"/>
          <p:nvPr/>
        </p:nvSpPr>
        <p:spPr>
          <a:xfrm>
            <a:off x="2684373" y="7314425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595175F-7439-4335-A8DA-9A59CC8C0498}"/>
              </a:ext>
            </a:extLst>
          </p:cNvPr>
          <p:cNvSpPr txBox="1"/>
          <p:nvPr/>
        </p:nvSpPr>
        <p:spPr>
          <a:xfrm>
            <a:off x="2783984" y="6258944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M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2DE68F94-9A05-418F-8662-A7FF887EB09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4818" y="5497834"/>
            <a:ext cx="1012635" cy="1373508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17A81535-4CBC-4428-AFA0-106E65FAA04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4818" y="7037578"/>
            <a:ext cx="1098811" cy="1257300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7F86EBF8-1FD4-498E-A50D-7CAB9245D1E0}"/>
              </a:ext>
            </a:extLst>
          </p:cNvPr>
          <p:cNvSpPr txBox="1"/>
          <p:nvPr/>
        </p:nvSpPr>
        <p:spPr>
          <a:xfrm>
            <a:off x="3812611" y="605816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04FCB06-297F-43EE-BFAA-F6E2F389F8CC}"/>
              </a:ext>
            </a:extLst>
          </p:cNvPr>
          <p:cNvSpPr txBox="1"/>
          <p:nvPr/>
        </p:nvSpPr>
        <p:spPr>
          <a:xfrm>
            <a:off x="3722615" y="786142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8E2014D0-DEC1-4050-87D4-E079EFBB558D}"/>
              </a:ext>
            </a:extLst>
          </p:cNvPr>
          <p:cNvSpPr/>
          <p:nvPr/>
        </p:nvSpPr>
        <p:spPr>
          <a:xfrm>
            <a:off x="4300383" y="6151780"/>
            <a:ext cx="690718" cy="179847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D35F2545-1790-4C01-A26B-2FFF09B92CF4}"/>
              </a:ext>
            </a:extLst>
          </p:cNvPr>
          <p:cNvSpPr/>
          <p:nvPr/>
        </p:nvSpPr>
        <p:spPr>
          <a:xfrm>
            <a:off x="4382740" y="7794362"/>
            <a:ext cx="690718" cy="179847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0AE8D4A-B6C8-406A-A51D-0C58749E5204}"/>
              </a:ext>
            </a:extLst>
          </p:cNvPr>
          <p:cNvSpPr txBox="1"/>
          <p:nvPr/>
        </p:nvSpPr>
        <p:spPr>
          <a:xfrm>
            <a:off x="4314037" y="5186786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E1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9550B4B-D9CA-4175-A141-534548F2E16B}"/>
              </a:ext>
            </a:extLst>
          </p:cNvPr>
          <p:cNvSpPr txBox="1"/>
          <p:nvPr/>
        </p:nvSpPr>
        <p:spPr>
          <a:xfrm>
            <a:off x="5111356" y="610320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M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C9C6491-C020-4CDA-BB45-078B41C5CDC7}"/>
              </a:ext>
            </a:extLst>
          </p:cNvPr>
          <p:cNvSpPr txBox="1"/>
          <p:nvPr/>
        </p:nvSpPr>
        <p:spPr>
          <a:xfrm>
            <a:off x="5203629" y="7733839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4912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2B6592F-3C69-4631-BAC3-AECBE73D932F}"/>
              </a:ext>
            </a:extLst>
          </p:cNvPr>
          <p:cNvSpPr txBox="1"/>
          <p:nvPr/>
        </p:nvSpPr>
        <p:spPr>
          <a:xfrm>
            <a:off x="0" y="0"/>
            <a:ext cx="1039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J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96F076F-6D72-4583-9634-698713C9BB7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8354" y="2750820"/>
            <a:ext cx="1341120" cy="85344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F17C913-EA8D-434E-8270-E6468BD1215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357804">
            <a:off x="895668" y="1070883"/>
            <a:ext cx="1426493" cy="1275267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9AD8EEDB-D8F8-449F-B862-16424F28BB8B}"/>
              </a:ext>
            </a:extLst>
          </p:cNvPr>
          <p:cNvSpPr/>
          <p:nvPr/>
        </p:nvSpPr>
        <p:spPr>
          <a:xfrm>
            <a:off x="1285175" y="1418671"/>
            <a:ext cx="772225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BEAE3D2-1333-4DEC-8C1A-D209E221A357}"/>
              </a:ext>
            </a:extLst>
          </p:cNvPr>
          <p:cNvSpPr txBox="1"/>
          <p:nvPr/>
        </p:nvSpPr>
        <p:spPr>
          <a:xfrm>
            <a:off x="545382" y="328315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D263BBB-AAC0-454A-8EF3-D569B6185AA5}"/>
              </a:ext>
            </a:extLst>
          </p:cNvPr>
          <p:cNvSpPr txBox="1"/>
          <p:nvPr/>
        </p:nvSpPr>
        <p:spPr>
          <a:xfrm>
            <a:off x="630342" y="143492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2BDD123-0FD8-472F-97D1-AF144E784102}"/>
              </a:ext>
            </a:extLst>
          </p:cNvPr>
          <p:cNvSpPr txBox="1"/>
          <p:nvPr/>
        </p:nvSpPr>
        <p:spPr>
          <a:xfrm>
            <a:off x="2322125" y="1430864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A2AEC8A-2DC9-4EF9-A708-73DC96BA7C1D}"/>
              </a:ext>
            </a:extLst>
          </p:cNvPr>
          <p:cNvSpPr txBox="1"/>
          <p:nvPr/>
        </p:nvSpPr>
        <p:spPr>
          <a:xfrm>
            <a:off x="2245859" y="3252678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C98EC33-6F2E-4B23-B1D1-1ED4D00E69BA}"/>
              </a:ext>
            </a:extLst>
          </p:cNvPr>
          <p:cNvSpPr txBox="1"/>
          <p:nvPr/>
        </p:nvSpPr>
        <p:spPr>
          <a:xfrm>
            <a:off x="1136250" y="662329"/>
            <a:ext cx="9211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AW264.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D7EE9219-B416-43A7-A7AF-F12245EE1A7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38378" y="2750820"/>
            <a:ext cx="1164990" cy="103889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DC5D315-FD22-47C2-BB97-BA0D6030B0E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23208" y="1028422"/>
            <a:ext cx="1280160" cy="1295401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D495336-2CA3-488C-894D-9F4796A8B60D}"/>
              </a:ext>
            </a:extLst>
          </p:cNvPr>
          <p:cNvSpPr txBox="1"/>
          <p:nvPr/>
        </p:nvSpPr>
        <p:spPr>
          <a:xfrm>
            <a:off x="3608768" y="145778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51BABFE-B81B-4B03-8C5D-E088E407CB43}"/>
              </a:ext>
            </a:extLst>
          </p:cNvPr>
          <p:cNvSpPr txBox="1"/>
          <p:nvPr/>
        </p:nvSpPr>
        <p:spPr>
          <a:xfrm>
            <a:off x="3646868" y="324740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70B9E8C-212A-4174-B7CA-D20DBC08D9D0}"/>
              </a:ext>
            </a:extLst>
          </p:cNvPr>
          <p:cNvSpPr txBox="1"/>
          <p:nvPr/>
        </p:nvSpPr>
        <p:spPr>
          <a:xfrm>
            <a:off x="5179300" y="3108907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FFBB033-E39D-4E4D-A013-997609A7D533}"/>
              </a:ext>
            </a:extLst>
          </p:cNvPr>
          <p:cNvSpPr txBox="1"/>
          <p:nvPr/>
        </p:nvSpPr>
        <p:spPr>
          <a:xfrm>
            <a:off x="5238869" y="1350048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8463604-EAEA-4853-89D0-0DC84F74EF5A}"/>
              </a:ext>
            </a:extLst>
          </p:cNvPr>
          <p:cNvSpPr txBox="1"/>
          <p:nvPr/>
        </p:nvSpPr>
        <p:spPr>
          <a:xfrm>
            <a:off x="4248939" y="662328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2A181752-B991-4EF9-BF20-EE3270D7BCA2}"/>
              </a:ext>
            </a:extLst>
          </p:cNvPr>
          <p:cNvSpPr/>
          <p:nvPr/>
        </p:nvSpPr>
        <p:spPr>
          <a:xfrm>
            <a:off x="1182939" y="3231352"/>
            <a:ext cx="772225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ADD0457-3495-49A1-B3F0-D87A73A32CB4}"/>
              </a:ext>
            </a:extLst>
          </p:cNvPr>
          <p:cNvSpPr/>
          <p:nvPr/>
        </p:nvSpPr>
        <p:spPr>
          <a:xfrm>
            <a:off x="4174152" y="1372511"/>
            <a:ext cx="703485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31FEA311-7F5C-458F-9D1C-A34ACE5CA464}"/>
              </a:ext>
            </a:extLst>
          </p:cNvPr>
          <p:cNvSpPr/>
          <p:nvPr/>
        </p:nvSpPr>
        <p:spPr>
          <a:xfrm>
            <a:off x="4233699" y="3102626"/>
            <a:ext cx="688245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A97D78D-C005-47F3-A0FA-DA2F87067DB7}"/>
              </a:ext>
            </a:extLst>
          </p:cNvPr>
          <p:cNvSpPr txBox="1"/>
          <p:nvPr/>
        </p:nvSpPr>
        <p:spPr>
          <a:xfrm>
            <a:off x="28101" y="5014476"/>
            <a:ext cx="10839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E3F0A3B8-103A-4714-892F-EC845DCC473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85513" y="5649026"/>
            <a:ext cx="1170172" cy="1846815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7B53BDF2-AD61-4598-89EC-2150A2E6D00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93452" y="8579679"/>
            <a:ext cx="1491494" cy="1038893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F0B648F9-FF22-477E-9978-59BFD10838C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67042" y="5533905"/>
            <a:ext cx="1322553" cy="1262667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4A140259-4F8B-476D-995E-F64DD77B836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85415" y="7804826"/>
            <a:ext cx="1247296" cy="12943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87931544-E1E5-4271-8D64-5546493E866F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73054" y="6962918"/>
            <a:ext cx="1333219" cy="1447612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98463461-7525-4B6B-8E1E-90521031960F}"/>
              </a:ext>
            </a:extLst>
          </p:cNvPr>
          <p:cNvSpPr/>
          <p:nvPr/>
        </p:nvSpPr>
        <p:spPr>
          <a:xfrm>
            <a:off x="1760752" y="6538549"/>
            <a:ext cx="772225" cy="250871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5F8CBA39-3D1A-4262-9203-6E8F5A88F282}"/>
              </a:ext>
            </a:extLst>
          </p:cNvPr>
          <p:cNvSpPr/>
          <p:nvPr/>
        </p:nvSpPr>
        <p:spPr>
          <a:xfrm>
            <a:off x="1763889" y="7879409"/>
            <a:ext cx="772225" cy="250871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535BE9D7-0AB9-498A-B4AE-9FFB3996BF70}"/>
              </a:ext>
            </a:extLst>
          </p:cNvPr>
          <p:cNvSpPr/>
          <p:nvPr/>
        </p:nvSpPr>
        <p:spPr>
          <a:xfrm>
            <a:off x="4213164" y="5767187"/>
            <a:ext cx="772225" cy="250871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A81E4A6B-AF3F-4FF6-9C44-935FED922659}"/>
              </a:ext>
            </a:extLst>
          </p:cNvPr>
          <p:cNvSpPr/>
          <p:nvPr/>
        </p:nvSpPr>
        <p:spPr>
          <a:xfrm>
            <a:off x="4206441" y="7561288"/>
            <a:ext cx="772225" cy="250871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2B8D7378-C680-4BF3-8EFA-B722714BB1BE}"/>
              </a:ext>
            </a:extLst>
          </p:cNvPr>
          <p:cNvSpPr/>
          <p:nvPr/>
        </p:nvSpPr>
        <p:spPr>
          <a:xfrm>
            <a:off x="4253086" y="9093095"/>
            <a:ext cx="772225" cy="250871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E9A14721-42D8-4C8D-855A-04139DF7488F}"/>
              </a:ext>
            </a:extLst>
          </p:cNvPr>
          <p:cNvSpPr txBox="1"/>
          <p:nvPr/>
        </p:nvSpPr>
        <p:spPr>
          <a:xfrm>
            <a:off x="3514926" y="928009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023CF02-6335-4621-AD84-0FDCFD8B5780}"/>
              </a:ext>
            </a:extLst>
          </p:cNvPr>
          <p:cNvSpPr txBox="1"/>
          <p:nvPr/>
        </p:nvSpPr>
        <p:spPr>
          <a:xfrm>
            <a:off x="5389696" y="9093095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67AD9EE-A356-495B-AC72-4D02ACDE18B9}"/>
              </a:ext>
            </a:extLst>
          </p:cNvPr>
          <p:cNvSpPr txBox="1"/>
          <p:nvPr/>
        </p:nvSpPr>
        <p:spPr>
          <a:xfrm>
            <a:off x="3551864" y="57002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88C55E0-6763-4BAE-BA48-725F28C5D73B}"/>
              </a:ext>
            </a:extLst>
          </p:cNvPr>
          <p:cNvSpPr txBox="1"/>
          <p:nvPr/>
        </p:nvSpPr>
        <p:spPr>
          <a:xfrm>
            <a:off x="3545142" y="74098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C592F5F-2EDB-4714-A599-6705A183C19F}"/>
              </a:ext>
            </a:extLst>
          </p:cNvPr>
          <p:cNvSpPr txBox="1"/>
          <p:nvPr/>
        </p:nvSpPr>
        <p:spPr>
          <a:xfrm>
            <a:off x="5146117" y="573391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EE051B9-05E8-41B6-B7FB-78EF6AF31A11}"/>
              </a:ext>
            </a:extLst>
          </p:cNvPr>
          <p:cNvSpPr txBox="1"/>
          <p:nvPr/>
        </p:nvSpPr>
        <p:spPr>
          <a:xfrm>
            <a:off x="5218102" y="753571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EAD3320-AEE8-404E-9B82-31163C95AFD5}"/>
              </a:ext>
            </a:extLst>
          </p:cNvPr>
          <p:cNvSpPr txBox="1"/>
          <p:nvPr/>
        </p:nvSpPr>
        <p:spPr>
          <a:xfrm>
            <a:off x="1112938" y="628516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D8D6241-9033-4106-9240-9ECD43F65877}"/>
              </a:ext>
            </a:extLst>
          </p:cNvPr>
          <p:cNvSpPr txBox="1"/>
          <p:nvPr/>
        </p:nvSpPr>
        <p:spPr>
          <a:xfrm>
            <a:off x="1171057" y="7965266"/>
            <a:ext cx="490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C945C89-33E8-4242-83CE-08B3C68DDFA6}"/>
              </a:ext>
            </a:extLst>
          </p:cNvPr>
          <p:cNvSpPr txBox="1"/>
          <p:nvPr/>
        </p:nvSpPr>
        <p:spPr>
          <a:xfrm>
            <a:off x="2634208" y="6516002"/>
            <a:ext cx="777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D642D58-19D7-4324-AA01-6EBE1F7C8FBE}"/>
              </a:ext>
            </a:extLst>
          </p:cNvPr>
          <p:cNvSpPr txBox="1"/>
          <p:nvPr/>
        </p:nvSpPr>
        <p:spPr>
          <a:xfrm>
            <a:off x="2670925" y="7879409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88268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13D710E-3F92-4BBA-B4E7-F2ED125ACF0B}"/>
              </a:ext>
            </a:extLst>
          </p:cNvPr>
          <p:cNvSpPr txBox="1"/>
          <p:nvPr/>
        </p:nvSpPr>
        <p:spPr>
          <a:xfrm>
            <a:off x="0" y="5906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D6A895F-A170-47B8-9109-C4DD3AA1D01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3167" y="891540"/>
            <a:ext cx="1158240" cy="115824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810A618-5E6D-4FAB-9DC4-FAE14BD21B8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3167" y="2232660"/>
            <a:ext cx="1143000" cy="86868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4934F18-C361-453C-9330-1A56A9851609}"/>
              </a:ext>
            </a:extLst>
          </p:cNvPr>
          <p:cNvSpPr txBox="1"/>
          <p:nvPr/>
        </p:nvSpPr>
        <p:spPr>
          <a:xfrm>
            <a:off x="566582" y="264307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2143195-721B-4192-98BA-117BBFD92E30}"/>
              </a:ext>
            </a:extLst>
          </p:cNvPr>
          <p:cNvSpPr txBox="1"/>
          <p:nvPr/>
        </p:nvSpPr>
        <p:spPr>
          <a:xfrm>
            <a:off x="673052" y="124334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D896ABC-AA1D-41F1-B216-C4E4DBC57A0A}"/>
              </a:ext>
            </a:extLst>
          </p:cNvPr>
          <p:cNvSpPr txBox="1"/>
          <p:nvPr/>
        </p:nvSpPr>
        <p:spPr>
          <a:xfrm>
            <a:off x="2129792" y="1120140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C05CC11-E9DE-4BCF-8BFA-2B464EE36968}"/>
              </a:ext>
            </a:extLst>
          </p:cNvPr>
          <p:cNvSpPr txBox="1"/>
          <p:nvPr/>
        </p:nvSpPr>
        <p:spPr>
          <a:xfrm>
            <a:off x="5733871" y="2698322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C5786415-0FF7-47E0-BF93-5256D76F4DBC}"/>
              </a:ext>
            </a:extLst>
          </p:cNvPr>
          <p:cNvSpPr/>
          <p:nvPr/>
        </p:nvSpPr>
        <p:spPr>
          <a:xfrm>
            <a:off x="1152901" y="2524125"/>
            <a:ext cx="637799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DD7645B6-87FC-4BF5-A52F-6C17CF2807F6}"/>
              </a:ext>
            </a:extLst>
          </p:cNvPr>
          <p:cNvSpPr/>
          <p:nvPr/>
        </p:nvSpPr>
        <p:spPr>
          <a:xfrm>
            <a:off x="1187420" y="1120140"/>
            <a:ext cx="637799" cy="221257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A21413A-9324-46E3-83A9-6BAAC2C2A0CF}"/>
              </a:ext>
            </a:extLst>
          </p:cNvPr>
          <p:cNvSpPr txBox="1"/>
          <p:nvPr/>
        </p:nvSpPr>
        <p:spPr>
          <a:xfrm>
            <a:off x="3429000" y="59060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5Q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5E6AB1B6-D269-442F-8454-914EA6F6F9D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6044" y="941070"/>
            <a:ext cx="1607821" cy="105918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9BC0779-3446-4FCD-A44A-0273155594E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6044" y="2232660"/>
            <a:ext cx="1524000" cy="105918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93E4E009-9BA6-4AC9-8A67-581BF6F0A5AE}"/>
              </a:ext>
            </a:extLst>
          </p:cNvPr>
          <p:cNvSpPr txBox="1"/>
          <p:nvPr/>
        </p:nvSpPr>
        <p:spPr>
          <a:xfrm>
            <a:off x="3755373" y="278679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29DD89A-BB99-477D-9003-938CFE51B5AB}"/>
              </a:ext>
            </a:extLst>
          </p:cNvPr>
          <p:cNvSpPr txBox="1"/>
          <p:nvPr/>
        </p:nvSpPr>
        <p:spPr>
          <a:xfrm>
            <a:off x="2121407" y="2538025"/>
            <a:ext cx="717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46E3D74C-1185-43FB-B2E8-1749F2A6ABE6}"/>
              </a:ext>
            </a:extLst>
          </p:cNvPr>
          <p:cNvSpPr/>
          <p:nvPr/>
        </p:nvSpPr>
        <p:spPr>
          <a:xfrm>
            <a:off x="4368541" y="2676525"/>
            <a:ext cx="1155959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28112E2-6176-4185-98E6-39E8AECCF480}"/>
              </a:ext>
            </a:extLst>
          </p:cNvPr>
          <p:cNvSpPr/>
          <p:nvPr/>
        </p:nvSpPr>
        <p:spPr>
          <a:xfrm>
            <a:off x="4444741" y="1191877"/>
            <a:ext cx="1155959" cy="257452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F70FB98-D19F-4EE7-9814-F87FE0756181}"/>
              </a:ext>
            </a:extLst>
          </p:cNvPr>
          <p:cNvSpPr txBox="1"/>
          <p:nvPr/>
        </p:nvSpPr>
        <p:spPr>
          <a:xfrm>
            <a:off x="3841471" y="129558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C2EB1FA-F587-4529-A1E1-431AF3E8DB53}"/>
              </a:ext>
            </a:extLst>
          </p:cNvPr>
          <p:cNvSpPr txBox="1"/>
          <p:nvPr/>
        </p:nvSpPr>
        <p:spPr>
          <a:xfrm>
            <a:off x="3849856" y="96634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D296D7D-7B23-48A1-80AB-FA8DA78DD105}"/>
              </a:ext>
            </a:extLst>
          </p:cNvPr>
          <p:cNvSpPr txBox="1"/>
          <p:nvPr/>
        </p:nvSpPr>
        <p:spPr>
          <a:xfrm>
            <a:off x="670627" y="85076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105EB05-0876-4992-A0AE-454BB6E5CF2E}"/>
              </a:ext>
            </a:extLst>
          </p:cNvPr>
          <p:cNvSpPr txBox="1"/>
          <p:nvPr/>
        </p:nvSpPr>
        <p:spPr>
          <a:xfrm>
            <a:off x="5719116" y="1202897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9983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62</Words>
  <Application>Microsoft Office PowerPoint</Application>
  <PresentationFormat>A4 纸张(210x297 毫米)</PresentationFormat>
  <Paragraphs>5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Zhang</dc:creator>
  <cp:lastModifiedBy>YanZhang</cp:lastModifiedBy>
  <cp:revision>10</cp:revision>
  <dcterms:created xsi:type="dcterms:W3CDTF">2025-05-09T01:51:36Z</dcterms:created>
  <dcterms:modified xsi:type="dcterms:W3CDTF">2025-05-31T06:25:07Z</dcterms:modified>
</cp:coreProperties>
</file>